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9" r:id="rId5"/>
    <p:sldId id="258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4.tiff"/><Relationship Id="rId1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6.tiff"/><Relationship Id="rId1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gaba AR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8430" y="218440"/>
            <a:ext cx="5948045" cy="447865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012190" y="4816475"/>
            <a:ext cx="4488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BAAR                                               51 kDa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2739390" y="2039620"/>
            <a:ext cx="7994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1  2  3</a:t>
            </a:r>
            <a:endParaRPr lang="en-US" altLang="zh-CN"/>
          </a:p>
        </p:txBody>
      </p:sp>
      <p:pic>
        <p:nvPicPr>
          <p:cNvPr id="7" name="图片 6" descr="tubulin-gaba AR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04585" y="218440"/>
            <a:ext cx="5948045" cy="447865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6934200" y="4816475"/>
            <a:ext cx="4488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Tubulin                                         55 kDa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8696325" y="1805305"/>
            <a:ext cx="9124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3  2  1</a:t>
            </a:r>
            <a:endParaRPr lang="en-US" altLang="zh-CN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 descr="eNOS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4775" y="76200"/>
            <a:ext cx="5786120" cy="435673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869315" y="4540885"/>
            <a:ext cx="4488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NOS                                            130 kDa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2139950" y="2524760"/>
            <a:ext cx="9505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1  2  3 4</a:t>
            </a:r>
            <a:endParaRPr lang="en-US" altLang="zh-CN"/>
          </a:p>
        </p:txBody>
      </p:sp>
      <p:pic>
        <p:nvPicPr>
          <p:cNvPr id="9" name="图片 8" descr="Actinb-eNOS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8240" y="76200"/>
            <a:ext cx="5805805" cy="437134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7362825" y="4540885"/>
            <a:ext cx="4488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Actin                                           43 kDa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8201025" y="2223135"/>
            <a:ext cx="9505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1  2  3 4</a:t>
            </a:r>
            <a:endParaRPr lang="en-US" altLang="zh-CN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pkc 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7310" y="57150"/>
            <a:ext cx="5785485" cy="43561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146810" y="4759960"/>
            <a:ext cx="36264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KC-α                                         77 kDa</a:t>
            </a:r>
            <a:endParaRPr lang="en-US" altLang="zh-CN"/>
          </a:p>
        </p:txBody>
      </p:sp>
      <p:pic>
        <p:nvPicPr>
          <p:cNvPr id="5" name="图片 4" descr="Bcl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36665" y="57150"/>
            <a:ext cx="5761990" cy="433895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7404100" y="4759960"/>
            <a:ext cx="36264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cl-2                                        26 kDa</a:t>
            </a:r>
            <a:endParaRPr lang="en-US" altLang="zh-CN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GABAAR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6200" y="80645"/>
            <a:ext cx="5871845" cy="442150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767715" y="4635500"/>
            <a:ext cx="4488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BAAR                                           51 kDa</a:t>
            </a:r>
            <a:endParaRPr lang="en-US" altLang="zh-CN"/>
          </a:p>
        </p:txBody>
      </p:sp>
      <p:pic>
        <p:nvPicPr>
          <p:cNvPr id="5" name="图片 4" descr="tubulin-GABAAR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59500" y="80645"/>
            <a:ext cx="5894070" cy="443801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7033260" y="4635500"/>
            <a:ext cx="4488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β-Tubulin                                           55 kDa</a:t>
            </a:r>
            <a:endParaRPr lang="en-US" altLang="zh-CN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5</Words>
  <Application>WPS 演示</Application>
  <PresentationFormat>宽屏</PresentationFormat>
  <Paragraphs>2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1" baseType="lpstr">
      <vt:lpstr>Arial</vt:lpstr>
      <vt:lpstr>宋体</vt:lpstr>
      <vt:lpstr>Wingdings</vt:lpstr>
      <vt:lpstr>Arial Unicode MS</vt:lpstr>
      <vt:lpstr>Calibri</vt:lpstr>
      <vt:lpstr>微软雅黑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fangwangyi</cp:lastModifiedBy>
  <cp:revision>4</cp:revision>
  <dcterms:created xsi:type="dcterms:W3CDTF">2022-04-28T03:28:45Z</dcterms:created>
  <dcterms:modified xsi:type="dcterms:W3CDTF">2022-04-28T03:42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55274ACA33749BAB35700E0FF846794</vt:lpwstr>
  </property>
  <property fmtid="{D5CDD505-2E9C-101B-9397-08002B2CF9AE}" pid="3" name="KSOProductBuildVer">
    <vt:lpwstr>2052-11.1.0.11622</vt:lpwstr>
  </property>
</Properties>
</file>